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12192000" cy="6858000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014" autoAdjust="0"/>
    <p:restoredTop sz="93447" autoAdjust="0"/>
  </p:normalViewPr>
  <p:slideViewPr>
    <p:cSldViewPr snapToGrid="0">
      <p:cViewPr varScale="1">
        <p:scale>
          <a:sx n="107" d="100"/>
          <a:sy n="107" d="100"/>
        </p:scale>
        <p:origin x="120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34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34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878891-3B70-4B94-BAEE-88FEB18586E5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54113"/>
            <a:ext cx="5540375" cy="31162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44861"/>
            <a:ext cx="5608320" cy="363670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37840" cy="4634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9"/>
            <a:ext cx="3037840" cy="4634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97DE3F-8F04-476B-AF8E-D0D1D2CF36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376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897DE3F-8F04-476B-AF8E-D0D1D2CF36A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9703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DECF64-62E6-4B8E-90D5-84029C0D69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EFC55DB-270A-FE06-C0C2-8C3B7960E0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36E5E1-EFE0-D916-EE58-848BFE985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624415-F5A9-5098-5E2E-9C0587248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5B319-3B47-4B86-1939-2395AC0E0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070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A48B98-5F78-5FAE-F487-932D8CDB55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050F19-B690-1C98-4C97-C2EB701659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47D955-E84D-DA92-71E0-19983DE7E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EE7442-0FA0-0662-4880-EB70B5A38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A60A8C-DACC-C25D-EA31-228637473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473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AFAA582-80EA-8FFE-6717-8F7660FD22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06AB09-1D1B-598A-3196-87DE1F9B81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1D5950-191C-D2E6-3974-A35C46151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E24EE5-9452-84DF-1A7F-3D2E1C52C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4FCC4B-8E7D-2B5D-0791-B950B7622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699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7103AE-2CA8-D316-AFE5-E63ABEA098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C24A61-629B-67A4-921D-8E595D3372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1DC599-085D-F352-6523-1CE8CB325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056BCE-8FDD-DC7C-BFA2-646FCFD7F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0E68B1-7026-6D9A-AA6F-86D5A2244A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700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159DE-46C7-7112-D8F4-AC0846F4D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751615-850B-8EE3-CD07-A41BCC96B0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6D6D35-6EEE-76CB-A7B3-9393C6285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E1BD30-B32D-92E3-8943-51DD5C005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903268-9725-9EEB-4396-3DC7FE27B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064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8EA0BF-849F-9564-DDCD-9D6E2F52E8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B608DA-F013-88F9-DECC-12F3D99742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B9CD44-76E8-EB8B-4F78-D717428AF9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3A4DA9-3BC5-6799-6BA0-C4C199171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50E6D9-1A18-C6B4-92F5-CFF5A6A40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A9BB7A-3135-2BF6-6401-D24789835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824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2FAC7F-C16F-D8C4-3D2E-AD085291B3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FF2890-2C17-37FD-0A84-F3892166DD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05EA2C-667E-3AB7-E26B-8A78C667B4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F41096-C25D-2831-01D7-2D3B934545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F951FEE-E9E0-6A8E-CE16-01F17AD753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F5F7DA7-B82C-D8DB-4CB6-A2EBB76DA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914E22-4792-AF32-96EE-BA1F85350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312D419-4CC5-FE70-6BE4-A530667D1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92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66F74C-1488-E29C-0EF7-29815B736E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A1B1ADC-5E07-A38D-9B4D-54BDEEA37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D3A60B-1623-0F7E-17FA-23C909281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73969C3-F1A5-90A5-D54E-E6258A2D4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6122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51E7637-6E7A-283C-6283-60359DF8E8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E4978E-B117-9941-29EC-A70E0FA98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FD7E27-B98F-6776-573A-EBACEC9A4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792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CDCCCB-1A48-3A52-BAE1-BFED42D545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934DA0-DFB0-DE2B-9DD5-A6E08348AD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25438A-98D3-6F12-5556-FD99DD4489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FD4AED-5D58-CA1B-FD3F-15506906C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9CB4F1-064F-7EE5-ECD7-3AF1818204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6C0817-EA96-463A-7FC5-0238C772BE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498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25C869-05BF-9F9A-18D3-0662AB90AA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0CA6735-F013-975D-91C3-36205A9383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843637-448B-0412-ED75-BFAC61BA7F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EF5FAF-7C11-BCAF-C5F7-9DB8DF122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637007-F46F-052B-F5EC-2C05A50B9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9C9CED-02A8-286D-37DD-8F866DB23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831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D47AEBF-16CF-0A62-F011-6A11A4E998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01EB9A-1BFA-5855-3D70-BBE95E170F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F12A36-4D3F-6E80-E41F-79314E9200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249328-9A8E-A056-517B-F9FD5B9D88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80532B-B214-6D1B-94CE-81305ED7AB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233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emf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A0E22A4D-4CEF-9C92-2B1C-2BA03D3C9EE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875" b="13590"/>
          <a:stretch/>
        </p:blipFill>
        <p:spPr>
          <a:xfrm>
            <a:off x="204762" y="3391005"/>
            <a:ext cx="2884880" cy="232332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3F39B95-7644-A4CD-3D27-BFDA6B0DE71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932" b="14327"/>
          <a:stretch/>
        </p:blipFill>
        <p:spPr>
          <a:xfrm>
            <a:off x="223932" y="805042"/>
            <a:ext cx="2865710" cy="228515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A0D464E-F366-D947-D01C-E2303DC09691}"/>
              </a:ext>
            </a:extLst>
          </p:cNvPr>
          <p:cNvSpPr txBox="1"/>
          <p:nvPr/>
        </p:nvSpPr>
        <p:spPr>
          <a:xfrm>
            <a:off x="439695" y="576252"/>
            <a:ext cx="9380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aw log-rank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07823C5-ED3D-3F1E-DD99-E7B28F499DF6}"/>
              </a:ext>
            </a:extLst>
          </p:cNvPr>
          <p:cNvSpPr txBox="1"/>
          <p:nvPr/>
        </p:nvSpPr>
        <p:spPr>
          <a:xfrm>
            <a:off x="436176" y="3187564"/>
            <a:ext cx="1016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DR corrected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97A8975D-CFFA-3147-F1AE-050DF629841C}"/>
              </a:ext>
            </a:extLst>
          </p:cNvPr>
          <p:cNvGrpSpPr/>
          <p:nvPr/>
        </p:nvGrpSpPr>
        <p:grpSpPr>
          <a:xfrm>
            <a:off x="3152564" y="536117"/>
            <a:ext cx="3481947" cy="5302940"/>
            <a:chOff x="3436778" y="444386"/>
            <a:chExt cx="3481947" cy="5302940"/>
          </a:xfrm>
        </p:grpSpPr>
        <p:pic>
          <p:nvPicPr>
            <p:cNvPr id="14" name="Picture 13" descr="A graph with red and blue lines and dots&#10;&#10;Description automatically generated">
              <a:extLst>
                <a:ext uri="{FF2B5EF4-FFF2-40B4-BE49-F238E27FC236}">
                  <a16:creationId xmlns:a16="http://schemas.microsoft.com/office/drawing/2014/main" id="{6047124D-EAF2-8900-5327-7E5A1699FD8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36778" y="1110673"/>
              <a:ext cx="3311895" cy="4636653"/>
            </a:xfrm>
            <a:prstGeom prst="rect">
              <a:avLst/>
            </a:prstGeom>
          </p:spPr>
        </p:pic>
        <p:sp>
          <p:nvSpPr>
            <p:cNvPr id="15" name="Title 1">
              <a:extLst>
                <a:ext uri="{FF2B5EF4-FFF2-40B4-BE49-F238E27FC236}">
                  <a16:creationId xmlns:a16="http://schemas.microsoft.com/office/drawing/2014/main" id="{67CD9058-69CC-1656-3C64-59FCC3DC4DFC}"/>
                </a:ext>
              </a:extLst>
            </p:cNvPr>
            <p:cNvSpPr txBox="1">
              <a:spLocks/>
            </p:cNvSpPr>
            <p:nvPr/>
          </p:nvSpPr>
          <p:spPr>
            <a:xfrm>
              <a:off x="4426051" y="444386"/>
              <a:ext cx="2492674" cy="1010131"/>
            </a:xfrm>
            <a:prstGeom prst="rect">
              <a:avLst/>
            </a:prstGeom>
          </p:spPr>
          <p:txBody>
            <a:bodyPr vert="horz" lIns="69681" tIns="34840" rIns="69681" bIns="34840" rtlCol="0" anchor="ctr">
              <a:normAutofit/>
            </a:bodyPr>
            <a:lstStyle>
              <a:lvl1pPr algn="l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ctr"/>
              <a:r>
                <a:rPr lang="en-US" sz="1219" dirty="0">
                  <a:latin typeface="Arial" panose="020B0604020202020204" pitchFamily="34" charset="0"/>
                  <a:cs typeface="Arial" panose="020B0604020202020204" pitchFamily="34" charset="0"/>
                </a:rPr>
                <a:t>All gene expression signatures associated with PFS</a:t>
              </a:r>
            </a:p>
          </p:txBody>
        </p:sp>
      </p:grpSp>
      <p:pic>
        <p:nvPicPr>
          <p:cNvPr id="17" name="Picture 16" descr="A graph of a cancer patient&#10;&#10;Description automatically generated">
            <a:extLst>
              <a:ext uri="{FF2B5EF4-FFF2-40B4-BE49-F238E27FC236}">
                <a16:creationId xmlns:a16="http://schemas.microsoft.com/office/drawing/2014/main" id="{CE0E0695-DB3F-19A0-B690-0C69E833F34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-40857"/>
          <a:stretch/>
        </p:blipFill>
        <p:spPr>
          <a:xfrm>
            <a:off x="8707057" y="4531833"/>
            <a:ext cx="2664564" cy="1418770"/>
          </a:xfrm>
          <a:prstGeom prst="rect">
            <a:avLst/>
          </a:prstGeom>
        </p:spPr>
      </p:pic>
      <p:pic>
        <p:nvPicPr>
          <p:cNvPr id="18" name="Picture 17" descr="A graph of a number of patients with a number of numbers&#10;&#10;Description automatically generated">
            <a:extLst>
              <a:ext uri="{FF2B5EF4-FFF2-40B4-BE49-F238E27FC236}">
                <a16:creationId xmlns:a16="http://schemas.microsoft.com/office/drawing/2014/main" id="{2A7AD4BA-C471-FE5B-E55D-A24202DB044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24202"/>
          <a:stretch/>
        </p:blipFill>
        <p:spPr>
          <a:xfrm>
            <a:off x="6955730" y="1174457"/>
            <a:ext cx="1433852" cy="1418770"/>
          </a:xfrm>
          <a:prstGeom prst="rect">
            <a:avLst/>
          </a:prstGeom>
        </p:spPr>
      </p:pic>
      <p:pic>
        <p:nvPicPr>
          <p:cNvPr id="19" name="Picture 18" descr="A graph of a number of patients with a number of numbers&#10;&#10;Description automatically generated">
            <a:extLst>
              <a:ext uri="{FF2B5EF4-FFF2-40B4-BE49-F238E27FC236}">
                <a16:creationId xmlns:a16="http://schemas.microsoft.com/office/drawing/2014/main" id="{CD356065-08AA-1E12-F859-F238E921A1E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24484"/>
          <a:stretch/>
        </p:blipFill>
        <p:spPr>
          <a:xfrm>
            <a:off x="8701038" y="1174457"/>
            <a:ext cx="1428541" cy="1418770"/>
          </a:xfrm>
          <a:prstGeom prst="rect">
            <a:avLst/>
          </a:prstGeom>
        </p:spPr>
      </p:pic>
      <p:pic>
        <p:nvPicPr>
          <p:cNvPr id="20" name="Picture 19" descr="A graph of a number of patients with a number of patients&#10;&#10;Description automatically generated">
            <a:extLst>
              <a:ext uri="{FF2B5EF4-FFF2-40B4-BE49-F238E27FC236}">
                <a16:creationId xmlns:a16="http://schemas.microsoft.com/office/drawing/2014/main" id="{5F298B95-4B67-8E5B-1F1A-AF0F72396D31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r="24412"/>
          <a:stretch/>
        </p:blipFill>
        <p:spPr>
          <a:xfrm>
            <a:off x="10473069" y="2886257"/>
            <a:ext cx="1429885" cy="1418770"/>
          </a:xfrm>
          <a:prstGeom prst="rect">
            <a:avLst/>
          </a:prstGeom>
        </p:spPr>
      </p:pic>
      <p:pic>
        <p:nvPicPr>
          <p:cNvPr id="21" name="Picture 20" descr="A graph of cancer patients&#10;&#10;Description automatically generated">
            <a:extLst>
              <a:ext uri="{FF2B5EF4-FFF2-40B4-BE49-F238E27FC236}">
                <a16:creationId xmlns:a16="http://schemas.microsoft.com/office/drawing/2014/main" id="{C17226B0-7B33-7D75-77C0-DF9CB82AAAB9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r="23254"/>
          <a:stretch/>
        </p:blipFill>
        <p:spPr>
          <a:xfrm>
            <a:off x="6945967" y="2846004"/>
            <a:ext cx="1451800" cy="1418770"/>
          </a:xfrm>
          <a:prstGeom prst="rect">
            <a:avLst/>
          </a:prstGeom>
        </p:spPr>
      </p:pic>
      <p:pic>
        <p:nvPicPr>
          <p:cNvPr id="22" name="Picture 21" descr="A graph of a number of patients&#10;&#10;Description automatically generated">
            <a:extLst>
              <a:ext uri="{FF2B5EF4-FFF2-40B4-BE49-F238E27FC236}">
                <a16:creationId xmlns:a16="http://schemas.microsoft.com/office/drawing/2014/main" id="{A07609E6-CAC6-1B43-64AB-4A9090F624C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4440"/>
          <a:stretch/>
        </p:blipFill>
        <p:spPr>
          <a:xfrm>
            <a:off x="8701038" y="2886257"/>
            <a:ext cx="1429363" cy="1418770"/>
          </a:xfrm>
          <a:prstGeom prst="rect">
            <a:avLst/>
          </a:prstGeom>
        </p:spPr>
      </p:pic>
      <p:pic>
        <p:nvPicPr>
          <p:cNvPr id="23" name="Picture 22" descr="A graph of a number of patients with a number of patients with their blood&#10;&#10;Description automatically generated">
            <a:extLst>
              <a:ext uri="{FF2B5EF4-FFF2-40B4-BE49-F238E27FC236}">
                <a16:creationId xmlns:a16="http://schemas.microsoft.com/office/drawing/2014/main" id="{A60E25AD-A9FC-2666-3894-0D9C13152F76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r="23742"/>
          <a:stretch/>
        </p:blipFill>
        <p:spPr>
          <a:xfrm>
            <a:off x="10460400" y="1197761"/>
            <a:ext cx="1442554" cy="141877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298A216-9620-7E98-05CB-2D9B97C27803}"/>
              </a:ext>
            </a:extLst>
          </p:cNvPr>
          <p:cNvSpPr txBox="1"/>
          <p:nvPr/>
        </p:nvSpPr>
        <p:spPr>
          <a:xfrm>
            <a:off x="67324" y="384851"/>
            <a:ext cx="527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7D3E53A-0B49-B7CE-8E81-B5422DAB0AF0}"/>
              </a:ext>
            </a:extLst>
          </p:cNvPr>
          <p:cNvSpPr txBox="1"/>
          <p:nvPr/>
        </p:nvSpPr>
        <p:spPr>
          <a:xfrm>
            <a:off x="83009" y="2992832"/>
            <a:ext cx="527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C9F408A-3D70-C25B-6917-DBF097984D15}"/>
              </a:ext>
            </a:extLst>
          </p:cNvPr>
          <p:cNvSpPr txBox="1"/>
          <p:nvPr/>
        </p:nvSpPr>
        <p:spPr>
          <a:xfrm>
            <a:off x="3681907" y="825541"/>
            <a:ext cx="527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0DC840F-5DCA-7748-021B-218ED46117AC}"/>
              </a:ext>
            </a:extLst>
          </p:cNvPr>
          <p:cNvSpPr txBox="1"/>
          <p:nvPr/>
        </p:nvSpPr>
        <p:spPr>
          <a:xfrm>
            <a:off x="6636779" y="1085547"/>
            <a:ext cx="527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55B3CFD-65BA-BBE8-9BE3-B753D3BF9FE5}"/>
              </a:ext>
            </a:extLst>
          </p:cNvPr>
          <p:cNvSpPr txBox="1"/>
          <p:nvPr/>
        </p:nvSpPr>
        <p:spPr>
          <a:xfrm>
            <a:off x="8429873" y="1093949"/>
            <a:ext cx="527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F19260D-B66A-75BB-4BBA-E20FE3E85288}"/>
              </a:ext>
            </a:extLst>
          </p:cNvPr>
          <p:cNvSpPr txBox="1"/>
          <p:nvPr/>
        </p:nvSpPr>
        <p:spPr>
          <a:xfrm>
            <a:off x="10236661" y="1091712"/>
            <a:ext cx="527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142FE8F-02F0-8EC9-6B91-F68AC47DF2B0}"/>
              </a:ext>
            </a:extLst>
          </p:cNvPr>
          <p:cNvSpPr txBox="1"/>
          <p:nvPr/>
        </p:nvSpPr>
        <p:spPr>
          <a:xfrm>
            <a:off x="6596488" y="2891669"/>
            <a:ext cx="527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A97B159-4D9F-BA85-927F-570FEBA726CD}"/>
              </a:ext>
            </a:extLst>
          </p:cNvPr>
          <p:cNvSpPr txBox="1"/>
          <p:nvPr/>
        </p:nvSpPr>
        <p:spPr>
          <a:xfrm>
            <a:off x="8389582" y="2900071"/>
            <a:ext cx="527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829817D-0828-A6EA-267E-3CD22333A23C}"/>
              </a:ext>
            </a:extLst>
          </p:cNvPr>
          <p:cNvSpPr txBox="1"/>
          <p:nvPr/>
        </p:nvSpPr>
        <p:spPr>
          <a:xfrm>
            <a:off x="10196370" y="2897834"/>
            <a:ext cx="527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880A18B-358D-04E1-5C4C-6966483205BE}"/>
              </a:ext>
            </a:extLst>
          </p:cNvPr>
          <p:cNvSpPr txBox="1"/>
          <p:nvPr/>
        </p:nvSpPr>
        <p:spPr>
          <a:xfrm>
            <a:off x="8386806" y="4679535"/>
            <a:ext cx="527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pic>
        <p:nvPicPr>
          <p:cNvPr id="2" name="Picture 1" descr="A graph with red and blue lines and dots&#10;&#10;Description automatically generated">
            <a:extLst>
              <a:ext uri="{FF2B5EF4-FFF2-40B4-BE49-F238E27FC236}">
                <a16:creationId xmlns:a16="http://schemas.microsoft.com/office/drawing/2014/main" id="{BF7E2F81-C0D1-D4CF-AEB8-960A41D3253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1090" t="91287"/>
          <a:stretch/>
        </p:blipFill>
        <p:spPr>
          <a:xfrm>
            <a:off x="961614" y="5679386"/>
            <a:ext cx="1619855" cy="403993"/>
          </a:xfrm>
          <a:prstGeom prst="rect">
            <a:avLst/>
          </a:prstGeom>
        </p:spPr>
      </p:pic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95B33BF1-5198-51FC-AA1F-C9CE28FE89F5}"/>
              </a:ext>
            </a:extLst>
          </p:cNvPr>
          <p:cNvCxnSpPr>
            <a:cxnSpLocks/>
          </p:cNvCxnSpPr>
          <p:nvPr/>
        </p:nvCxnSpPr>
        <p:spPr>
          <a:xfrm>
            <a:off x="489078" y="1526152"/>
            <a:ext cx="2525427" cy="0"/>
          </a:xfrm>
          <a:prstGeom prst="line">
            <a:avLst/>
          </a:prstGeom>
          <a:ln w="12700">
            <a:solidFill>
              <a:schemeClr val="accent2">
                <a:lumMod val="75000"/>
                <a:alpha val="49000"/>
              </a:schemeClr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889297AF-5DCD-0182-DEF1-8D47A500D5E2}"/>
              </a:ext>
            </a:extLst>
          </p:cNvPr>
          <p:cNvSpPr txBox="1"/>
          <p:nvPr/>
        </p:nvSpPr>
        <p:spPr>
          <a:xfrm>
            <a:off x="2639143" y="1526152"/>
            <a:ext cx="4235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0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21DDA7C-73D9-FDDC-0B23-61E89B01F96F}"/>
              </a:ext>
            </a:extLst>
          </p:cNvPr>
          <p:cNvSpPr txBox="1"/>
          <p:nvPr/>
        </p:nvSpPr>
        <p:spPr>
          <a:xfrm>
            <a:off x="223932" y="6302188"/>
            <a:ext cx="11851527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5. Top gene expression signatures associated with PFS in treatment-naive solid tissues at diagnosis.</a:t>
            </a:r>
            <a:r>
              <a:rPr lang="en-US" sz="9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(A-B) Volcano plots of hazard ratio from univariate cox regression between individual genes and PFS, and the (A) raw log-rank p-value and (B) FDR corrected log-rank p-value. (C) Forest plot of gene expression signatures and PFS hazard ratios. (D-J) Kaplan Meier plots of top genes expression signatures based on expression below (blue) or above (red) the median.</a:t>
            </a:r>
            <a:endParaRPr lang="en-US" sz="9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7533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47</TotalTime>
  <Words>118</Words>
  <Application>Microsoft Office PowerPoint</Application>
  <PresentationFormat>Widescreen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Bayani</dc:creator>
  <cp:lastModifiedBy>Quann, Karen</cp:lastModifiedBy>
  <cp:revision>309</cp:revision>
  <cp:lastPrinted>2023-08-16T18:12:39Z</cp:lastPrinted>
  <dcterms:created xsi:type="dcterms:W3CDTF">2023-05-04T15:52:47Z</dcterms:created>
  <dcterms:modified xsi:type="dcterms:W3CDTF">2025-10-21T17:14:25Z</dcterms:modified>
</cp:coreProperties>
</file>